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0" r:id="rId2"/>
  </p:sldIdLst>
  <p:sldSz cx="7588250" cy="10691813"/>
  <p:notesSz cx="6950075" cy="9236075"/>
  <p:defaultTextStyle>
    <a:defPPr>
      <a:defRPr lang="en-US"/>
    </a:defPPr>
    <a:lvl1pPr marL="0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478944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957887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1436831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1915774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2394718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2873661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3352605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3831549" algn="l" defTabSz="957887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 userDrawn="1">
          <p15:clr>
            <a:srgbClr val="A4A3A4"/>
          </p15:clr>
        </p15:guide>
        <p15:guide id="2" pos="239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K Pandey" initials="AP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276" autoAdjust="0"/>
    <p:restoredTop sz="94660"/>
  </p:normalViewPr>
  <p:slideViewPr>
    <p:cSldViewPr>
      <p:cViewPr varScale="1">
        <p:scale>
          <a:sx n="43" d="100"/>
          <a:sy n="43" d="100"/>
        </p:scale>
        <p:origin x="2448" y="68"/>
      </p:cViewPr>
      <p:guideLst>
        <p:guide orient="horz" pos="3368"/>
        <p:guide pos="239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96" d="100"/>
        <a:sy n="9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K%20Pandey\AppData\Local\Packages\microsoft.windowscommunicationsapps_8wekyb3d8bbwe\LocalState\Files\S0\97609\Attachments\qRT%20new%20result%5b497239%5d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K%20Pandey\AppData\Local\Packages\microsoft.windowscommunicationsapps_8wekyb3d8bbwe\LocalState\Files\S0\97609\Attachments\qRT%20new%20result%5b497239%5d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K%20Pandey\AppData\Local\Packages\microsoft.windowscommunicationsapps_8wekyb3d8bbwe\LocalState\Files\S0\97609\Attachments\qRT%20new%20result%5b497239%5d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K%20Pandey\AppData\Local\Packages\microsoft.windowscommunicationsapps_8wekyb3d8bbwe\LocalState\Files\S0\97609\Attachments\qRT%20new%20result%5b497239%5d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K%20Pandey\AppData\Local\Packages\microsoft.windowscommunicationsapps_8wekyb3d8bbwe\LocalState\Files\S0\97609\Attachments\qRT%20new%20result%5b497239%5d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K%20Pandey\AppData\Local\Packages\microsoft.windowscommunicationsapps_8wekyb3d8bbwe\LocalState\Files\S0\97609\Attachments\qRT%20new%20result%5b497239%5d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U$76:$U$78</c:f>
                <c:numCache>
                  <c:formatCode>General</c:formatCode>
                  <c:ptCount val="3"/>
                  <c:pt idx="0">
                    <c:v>0.18</c:v>
                  </c:pt>
                  <c:pt idx="1">
                    <c:v>0.57999999999999996</c:v>
                  </c:pt>
                  <c:pt idx="2">
                    <c:v>0.45</c:v>
                  </c:pt>
                </c:numCache>
              </c:numRef>
            </c:plus>
            <c:minus>
              <c:numRef>
                <c:f>Sheet1!$U$76:$U$78</c:f>
                <c:numCache>
                  <c:formatCode>General</c:formatCode>
                  <c:ptCount val="3"/>
                  <c:pt idx="0">
                    <c:v>0.18</c:v>
                  </c:pt>
                  <c:pt idx="1">
                    <c:v>0.57999999999999996</c:v>
                  </c:pt>
                  <c:pt idx="2">
                    <c:v>0.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S$76:$S$78</c:f>
              <c:strCache>
                <c:ptCount val="3"/>
                <c:pt idx="0">
                  <c:v>Col-0(EV)</c:v>
                </c:pt>
                <c:pt idx="1">
                  <c:v>#Line4</c:v>
                </c:pt>
                <c:pt idx="2">
                  <c:v>#Line6</c:v>
                </c:pt>
              </c:strCache>
            </c:strRef>
          </c:cat>
          <c:val>
            <c:numRef>
              <c:f>Sheet1!$T$76:$T$78</c:f>
              <c:numCache>
                <c:formatCode>General</c:formatCode>
                <c:ptCount val="3"/>
                <c:pt idx="0">
                  <c:v>0.9</c:v>
                </c:pt>
                <c:pt idx="1">
                  <c:v>2.7</c:v>
                </c:pt>
                <c:pt idx="2">
                  <c:v>4.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F90-47AD-9A2D-9E57AABDAA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3213768"/>
        <c:axId val="653220656"/>
      </c:barChart>
      <c:catAx>
        <c:axId val="6532137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53220656"/>
        <c:crosses val="autoZero"/>
        <c:auto val="1"/>
        <c:lblAlgn val="ctr"/>
        <c:lblOffset val="100"/>
        <c:noMultiLvlLbl val="0"/>
      </c:catAx>
      <c:valAx>
        <c:axId val="653220656"/>
        <c:scaling>
          <c:orientation val="minMax"/>
          <c:max val="8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53213768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82132443207444"/>
          <c:y val="4.0743946850179867E-2"/>
          <c:w val="0.7075536089411345"/>
          <c:h val="0.6262165803994347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U$76:$U$78</c:f>
                <c:numCache>
                  <c:formatCode>General</c:formatCode>
                  <c:ptCount val="3"/>
                  <c:pt idx="0">
                    <c:v>0.18</c:v>
                  </c:pt>
                  <c:pt idx="1">
                    <c:v>0.57999999999999996</c:v>
                  </c:pt>
                  <c:pt idx="2">
                    <c:v>0.45</c:v>
                  </c:pt>
                </c:numCache>
              </c:numRef>
            </c:plus>
            <c:minus>
              <c:numRef>
                <c:f>Sheet1!$U$76:$U$78</c:f>
                <c:numCache>
                  <c:formatCode>General</c:formatCode>
                  <c:ptCount val="3"/>
                  <c:pt idx="0">
                    <c:v>0.18</c:v>
                  </c:pt>
                  <c:pt idx="1">
                    <c:v>0.57999999999999996</c:v>
                  </c:pt>
                  <c:pt idx="2">
                    <c:v>0.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S$76:$S$78</c:f>
              <c:strCache>
                <c:ptCount val="3"/>
                <c:pt idx="0">
                  <c:v>Col-0(EV)</c:v>
                </c:pt>
                <c:pt idx="1">
                  <c:v>#Line4</c:v>
                </c:pt>
                <c:pt idx="2">
                  <c:v>#Line6</c:v>
                </c:pt>
              </c:strCache>
            </c:strRef>
          </c:cat>
          <c:val>
            <c:numRef>
              <c:f>Sheet1!$T$76:$T$78</c:f>
              <c:numCache>
                <c:formatCode>General</c:formatCode>
                <c:ptCount val="3"/>
                <c:pt idx="0">
                  <c:v>0.9</c:v>
                </c:pt>
                <c:pt idx="1">
                  <c:v>2.7</c:v>
                </c:pt>
                <c:pt idx="2">
                  <c:v>4.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E56-4ECA-AAF4-E22DA3F6B7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3213768"/>
        <c:axId val="653220656"/>
      </c:barChart>
      <c:catAx>
        <c:axId val="6532137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53220656"/>
        <c:crosses val="autoZero"/>
        <c:auto val="1"/>
        <c:lblAlgn val="ctr"/>
        <c:lblOffset val="100"/>
        <c:noMultiLvlLbl val="0"/>
      </c:catAx>
      <c:valAx>
        <c:axId val="653220656"/>
        <c:scaling>
          <c:orientation val="minMax"/>
          <c:max val="6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53213768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U$76:$U$78</c:f>
                <c:numCache>
                  <c:formatCode>General</c:formatCode>
                  <c:ptCount val="3"/>
                  <c:pt idx="0">
                    <c:v>0.18</c:v>
                  </c:pt>
                  <c:pt idx="1">
                    <c:v>0.57999999999999996</c:v>
                  </c:pt>
                  <c:pt idx="2">
                    <c:v>0.45</c:v>
                  </c:pt>
                </c:numCache>
              </c:numRef>
            </c:plus>
            <c:minus>
              <c:numRef>
                <c:f>Sheet1!$U$76:$U$78</c:f>
                <c:numCache>
                  <c:formatCode>General</c:formatCode>
                  <c:ptCount val="3"/>
                  <c:pt idx="0">
                    <c:v>0.18</c:v>
                  </c:pt>
                  <c:pt idx="1">
                    <c:v>0.57999999999999996</c:v>
                  </c:pt>
                  <c:pt idx="2">
                    <c:v>0.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S$76:$S$78</c:f>
              <c:strCache>
                <c:ptCount val="3"/>
                <c:pt idx="0">
                  <c:v>Col-0(EV)</c:v>
                </c:pt>
                <c:pt idx="1">
                  <c:v>#Line4</c:v>
                </c:pt>
                <c:pt idx="2">
                  <c:v>#Line6</c:v>
                </c:pt>
              </c:strCache>
            </c:strRef>
          </c:cat>
          <c:val>
            <c:numRef>
              <c:f>Sheet1!$T$76:$T$78</c:f>
              <c:numCache>
                <c:formatCode>General</c:formatCode>
                <c:ptCount val="3"/>
                <c:pt idx="0">
                  <c:v>0.9</c:v>
                </c:pt>
                <c:pt idx="1">
                  <c:v>2.7</c:v>
                </c:pt>
                <c:pt idx="2">
                  <c:v>4.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54D-49F5-B355-21468B24EA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3213768"/>
        <c:axId val="653220656"/>
      </c:barChart>
      <c:catAx>
        <c:axId val="6532137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53220656"/>
        <c:crosses val="autoZero"/>
        <c:auto val="1"/>
        <c:lblAlgn val="ctr"/>
        <c:lblOffset val="100"/>
        <c:noMultiLvlLbl val="0"/>
      </c:catAx>
      <c:valAx>
        <c:axId val="653220656"/>
        <c:scaling>
          <c:orientation val="minMax"/>
          <c:max val="1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53213768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800792181560648"/>
          <c:y val="7.0784304955047089E-2"/>
          <c:w val="0.74451534616071458"/>
          <c:h val="0.5787071635668619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U$76:$U$78</c:f>
                <c:numCache>
                  <c:formatCode>General</c:formatCode>
                  <c:ptCount val="3"/>
                  <c:pt idx="0">
                    <c:v>0.18</c:v>
                  </c:pt>
                  <c:pt idx="1">
                    <c:v>0.57999999999999996</c:v>
                  </c:pt>
                  <c:pt idx="2">
                    <c:v>0.45</c:v>
                  </c:pt>
                </c:numCache>
              </c:numRef>
            </c:plus>
            <c:minus>
              <c:numRef>
                <c:f>Sheet1!$U$76:$U$78</c:f>
                <c:numCache>
                  <c:formatCode>General</c:formatCode>
                  <c:ptCount val="3"/>
                  <c:pt idx="0">
                    <c:v>0.18</c:v>
                  </c:pt>
                  <c:pt idx="1">
                    <c:v>0.57999999999999996</c:v>
                  </c:pt>
                  <c:pt idx="2">
                    <c:v>0.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S$76:$S$78</c:f>
              <c:strCache>
                <c:ptCount val="3"/>
                <c:pt idx="0">
                  <c:v>Col-0(EV)</c:v>
                </c:pt>
                <c:pt idx="1">
                  <c:v>#Line4</c:v>
                </c:pt>
                <c:pt idx="2">
                  <c:v>#Line6</c:v>
                </c:pt>
              </c:strCache>
            </c:strRef>
          </c:cat>
          <c:val>
            <c:numRef>
              <c:f>Sheet1!$T$76:$T$78</c:f>
              <c:numCache>
                <c:formatCode>General</c:formatCode>
                <c:ptCount val="3"/>
                <c:pt idx="0">
                  <c:v>0.9</c:v>
                </c:pt>
                <c:pt idx="1">
                  <c:v>2.7</c:v>
                </c:pt>
                <c:pt idx="2">
                  <c:v>4.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6D6-4099-BF52-7B7AFF0230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3213768"/>
        <c:axId val="653220656"/>
      </c:barChart>
      <c:catAx>
        <c:axId val="6532137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53220656"/>
        <c:crosses val="autoZero"/>
        <c:auto val="1"/>
        <c:lblAlgn val="ctr"/>
        <c:lblOffset val="100"/>
        <c:noMultiLvlLbl val="0"/>
      </c:catAx>
      <c:valAx>
        <c:axId val="653220656"/>
        <c:scaling>
          <c:orientation val="minMax"/>
          <c:max val="9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53213768"/>
        <c:crosses val="autoZero"/>
        <c:crossBetween val="between"/>
        <c:majorUnit val="3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U$76:$U$78</c:f>
                <c:numCache>
                  <c:formatCode>General</c:formatCode>
                  <c:ptCount val="3"/>
                  <c:pt idx="0">
                    <c:v>0.18</c:v>
                  </c:pt>
                  <c:pt idx="1">
                    <c:v>0.57999999999999996</c:v>
                  </c:pt>
                  <c:pt idx="2">
                    <c:v>0.45</c:v>
                  </c:pt>
                </c:numCache>
              </c:numRef>
            </c:plus>
            <c:minus>
              <c:numRef>
                <c:f>Sheet1!$U$76:$U$78</c:f>
                <c:numCache>
                  <c:formatCode>General</c:formatCode>
                  <c:ptCount val="3"/>
                  <c:pt idx="0">
                    <c:v>0.18</c:v>
                  </c:pt>
                  <c:pt idx="1">
                    <c:v>0.57999999999999996</c:v>
                  </c:pt>
                  <c:pt idx="2">
                    <c:v>0.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S$76:$S$78</c:f>
              <c:strCache>
                <c:ptCount val="3"/>
                <c:pt idx="0">
                  <c:v>Col-0(EV)</c:v>
                </c:pt>
                <c:pt idx="1">
                  <c:v>#Line4</c:v>
                </c:pt>
                <c:pt idx="2">
                  <c:v>#Line6</c:v>
                </c:pt>
              </c:strCache>
            </c:strRef>
          </c:cat>
          <c:val>
            <c:numRef>
              <c:f>Sheet1!$T$76:$T$78</c:f>
              <c:numCache>
                <c:formatCode>General</c:formatCode>
                <c:ptCount val="3"/>
                <c:pt idx="0">
                  <c:v>0.9</c:v>
                </c:pt>
                <c:pt idx="1">
                  <c:v>2.7</c:v>
                </c:pt>
                <c:pt idx="2">
                  <c:v>4.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4FE-4CB1-B0C9-715E989E6C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3213768"/>
        <c:axId val="653220656"/>
      </c:barChart>
      <c:catAx>
        <c:axId val="6532137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53220656"/>
        <c:crosses val="autoZero"/>
        <c:auto val="1"/>
        <c:lblAlgn val="ctr"/>
        <c:lblOffset val="100"/>
        <c:noMultiLvlLbl val="0"/>
      </c:catAx>
      <c:valAx>
        <c:axId val="653220656"/>
        <c:scaling>
          <c:orientation val="minMax"/>
          <c:max val="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53213768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862712218185741"/>
          <c:y val="8.026978051224247E-2"/>
          <c:w val="0.78738253097523625"/>
          <c:h val="0.5967993651762790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U$76:$U$78</c:f>
                <c:numCache>
                  <c:formatCode>General</c:formatCode>
                  <c:ptCount val="3"/>
                  <c:pt idx="0">
                    <c:v>0.18</c:v>
                  </c:pt>
                  <c:pt idx="1">
                    <c:v>0.57999999999999996</c:v>
                  </c:pt>
                  <c:pt idx="2">
                    <c:v>0.45</c:v>
                  </c:pt>
                </c:numCache>
              </c:numRef>
            </c:plus>
            <c:minus>
              <c:numRef>
                <c:f>Sheet1!$U$76:$U$78</c:f>
                <c:numCache>
                  <c:formatCode>General</c:formatCode>
                  <c:ptCount val="3"/>
                  <c:pt idx="0">
                    <c:v>0.18</c:v>
                  </c:pt>
                  <c:pt idx="1">
                    <c:v>0.57999999999999996</c:v>
                  </c:pt>
                  <c:pt idx="2">
                    <c:v>0.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S$76:$S$78</c:f>
              <c:strCache>
                <c:ptCount val="3"/>
                <c:pt idx="0">
                  <c:v>Col-0(EV)</c:v>
                </c:pt>
                <c:pt idx="1">
                  <c:v>#Line4</c:v>
                </c:pt>
                <c:pt idx="2">
                  <c:v>#Line6</c:v>
                </c:pt>
              </c:strCache>
            </c:strRef>
          </c:cat>
          <c:val>
            <c:numRef>
              <c:f>Sheet1!$T$76:$T$78</c:f>
              <c:numCache>
                <c:formatCode>General</c:formatCode>
                <c:ptCount val="3"/>
                <c:pt idx="0">
                  <c:v>0.9</c:v>
                </c:pt>
                <c:pt idx="1">
                  <c:v>2.7</c:v>
                </c:pt>
                <c:pt idx="2">
                  <c:v>4.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834-479B-B61C-7EF79CE4270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3213768"/>
        <c:axId val="653220656"/>
      </c:barChart>
      <c:catAx>
        <c:axId val="6532137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53220656"/>
        <c:crosses val="autoZero"/>
        <c:auto val="1"/>
        <c:lblAlgn val="ctr"/>
        <c:lblOffset val="100"/>
        <c:noMultiLvlLbl val="0"/>
      </c:catAx>
      <c:valAx>
        <c:axId val="653220656"/>
        <c:scaling>
          <c:orientation val="minMax"/>
          <c:max val="6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53213768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11700" cy="46180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36767" y="0"/>
            <a:ext cx="3011700" cy="46180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E3909C8-BF3A-4EAB-B9A5-A6204233898E}" type="datetimeFigureOut">
              <a:rPr lang="en-IN" smtClean="0"/>
              <a:pPr/>
              <a:t>21-11-2021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6313" y="692150"/>
            <a:ext cx="2457450" cy="34639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008" y="4387137"/>
            <a:ext cx="5560060" cy="415623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772668"/>
            <a:ext cx="3011700" cy="4618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36767" y="8772668"/>
            <a:ext cx="3011700" cy="4618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662CD8-564F-4CAA-9389-C6C6097619A8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72355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78944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57887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436831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915774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394718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873661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352605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831549" algn="l" defTabSz="95788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9119" y="3321393"/>
            <a:ext cx="6450013" cy="2291811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38239" y="6058696"/>
            <a:ext cx="5311776" cy="273235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807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615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422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230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038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8845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3653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8461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01483" y="428171"/>
            <a:ext cx="1707356" cy="9122691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9413" y="428171"/>
            <a:ext cx="4995598" cy="912269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9419" y="6870481"/>
            <a:ext cx="6450013" cy="2123513"/>
          </a:xfrm>
        </p:spPr>
        <p:txBody>
          <a:bodyPr anchor="t"/>
          <a:lstStyle>
            <a:lvl1pPr algn="l">
              <a:defRPr sz="4216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9419" y="4531649"/>
            <a:ext cx="6450013" cy="2338834"/>
          </a:xfrm>
        </p:spPr>
        <p:txBody>
          <a:bodyPr anchor="b"/>
          <a:lstStyle>
            <a:lvl1pPr marL="0" indent="0">
              <a:buNone/>
              <a:defRPr sz="2108">
                <a:solidFill>
                  <a:schemeClr val="tx1">
                    <a:tint val="75000"/>
                  </a:schemeClr>
                </a:solidFill>
              </a:defRPr>
            </a:lvl1pPr>
            <a:lvl2pPr marL="480764" indent="0">
              <a:buNone/>
              <a:defRPr sz="1907">
                <a:solidFill>
                  <a:schemeClr val="tx1">
                    <a:tint val="75000"/>
                  </a:schemeClr>
                </a:solidFill>
              </a:defRPr>
            </a:lvl2pPr>
            <a:lvl3pPr marL="961527" indent="0">
              <a:buNone/>
              <a:defRPr sz="1706">
                <a:solidFill>
                  <a:schemeClr val="tx1">
                    <a:tint val="75000"/>
                  </a:schemeClr>
                </a:solidFill>
              </a:defRPr>
            </a:lvl3pPr>
            <a:lvl4pPr marL="1442291" indent="0">
              <a:buNone/>
              <a:defRPr sz="1506">
                <a:solidFill>
                  <a:schemeClr val="tx1">
                    <a:tint val="75000"/>
                  </a:schemeClr>
                </a:solidFill>
              </a:defRPr>
            </a:lvl4pPr>
            <a:lvl5pPr marL="1923054" indent="0">
              <a:buNone/>
              <a:defRPr sz="1506">
                <a:solidFill>
                  <a:schemeClr val="tx1">
                    <a:tint val="75000"/>
                  </a:schemeClr>
                </a:solidFill>
              </a:defRPr>
            </a:lvl5pPr>
            <a:lvl6pPr marL="2403818" indent="0">
              <a:buNone/>
              <a:defRPr sz="1506">
                <a:solidFill>
                  <a:schemeClr val="tx1">
                    <a:tint val="75000"/>
                  </a:schemeClr>
                </a:solidFill>
              </a:defRPr>
            </a:lvl6pPr>
            <a:lvl7pPr marL="2884581" indent="0">
              <a:buNone/>
              <a:defRPr sz="1506">
                <a:solidFill>
                  <a:schemeClr val="tx1">
                    <a:tint val="75000"/>
                  </a:schemeClr>
                </a:solidFill>
              </a:defRPr>
            </a:lvl7pPr>
            <a:lvl8pPr marL="3365345" indent="0">
              <a:buNone/>
              <a:defRPr sz="1506">
                <a:solidFill>
                  <a:schemeClr val="tx1">
                    <a:tint val="75000"/>
                  </a:schemeClr>
                </a:solidFill>
              </a:defRPr>
            </a:lvl8pPr>
            <a:lvl9pPr marL="3846109" indent="0">
              <a:buNone/>
              <a:defRPr sz="150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9413" y="2494758"/>
            <a:ext cx="3351477" cy="7056102"/>
          </a:xfrm>
        </p:spPr>
        <p:txBody>
          <a:bodyPr/>
          <a:lstStyle>
            <a:lvl1pPr>
              <a:defRPr sz="2911"/>
            </a:lvl1pPr>
            <a:lvl2pPr>
              <a:defRPr sz="2510"/>
            </a:lvl2pPr>
            <a:lvl3pPr>
              <a:defRPr sz="2108"/>
            </a:lvl3pPr>
            <a:lvl4pPr>
              <a:defRPr sz="1907"/>
            </a:lvl4pPr>
            <a:lvl5pPr>
              <a:defRPr sz="1907"/>
            </a:lvl5pPr>
            <a:lvl6pPr>
              <a:defRPr sz="1907"/>
            </a:lvl6pPr>
            <a:lvl7pPr>
              <a:defRPr sz="1907"/>
            </a:lvl7pPr>
            <a:lvl8pPr>
              <a:defRPr sz="1907"/>
            </a:lvl8pPr>
            <a:lvl9pPr>
              <a:defRPr sz="190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57360" y="2494758"/>
            <a:ext cx="3351477" cy="7056102"/>
          </a:xfrm>
        </p:spPr>
        <p:txBody>
          <a:bodyPr/>
          <a:lstStyle>
            <a:lvl1pPr>
              <a:defRPr sz="2911"/>
            </a:lvl1pPr>
            <a:lvl2pPr>
              <a:defRPr sz="2510"/>
            </a:lvl2pPr>
            <a:lvl3pPr>
              <a:defRPr sz="2108"/>
            </a:lvl3pPr>
            <a:lvl4pPr>
              <a:defRPr sz="1907"/>
            </a:lvl4pPr>
            <a:lvl5pPr>
              <a:defRPr sz="1907"/>
            </a:lvl5pPr>
            <a:lvl6pPr>
              <a:defRPr sz="1907"/>
            </a:lvl6pPr>
            <a:lvl7pPr>
              <a:defRPr sz="1907"/>
            </a:lvl7pPr>
            <a:lvl8pPr>
              <a:defRPr sz="1907"/>
            </a:lvl8pPr>
            <a:lvl9pPr>
              <a:defRPr sz="190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9414" y="2393286"/>
            <a:ext cx="3352795" cy="997407"/>
          </a:xfrm>
        </p:spPr>
        <p:txBody>
          <a:bodyPr anchor="b"/>
          <a:lstStyle>
            <a:lvl1pPr marL="0" indent="0">
              <a:buNone/>
              <a:defRPr sz="2510" b="1"/>
            </a:lvl1pPr>
            <a:lvl2pPr marL="480764" indent="0">
              <a:buNone/>
              <a:defRPr sz="2108" b="1"/>
            </a:lvl2pPr>
            <a:lvl3pPr marL="961527" indent="0">
              <a:buNone/>
              <a:defRPr sz="1907" b="1"/>
            </a:lvl3pPr>
            <a:lvl4pPr marL="1442291" indent="0">
              <a:buNone/>
              <a:defRPr sz="1706" b="1"/>
            </a:lvl4pPr>
            <a:lvl5pPr marL="1923054" indent="0">
              <a:buNone/>
              <a:defRPr sz="1706" b="1"/>
            </a:lvl5pPr>
            <a:lvl6pPr marL="2403818" indent="0">
              <a:buNone/>
              <a:defRPr sz="1706" b="1"/>
            </a:lvl6pPr>
            <a:lvl7pPr marL="2884581" indent="0">
              <a:buNone/>
              <a:defRPr sz="1706" b="1"/>
            </a:lvl7pPr>
            <a:lvl8pPr marL="3365345" indent="0">
              <a:buNone/>
              <a:defRPr sz="1706" b="1"/>
            </a:lvl8pPr>
            <a:lvl9pPr marL="3846109" indent="0">
              <a:buNone/>
              <a:defRPr sz="170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9414" y="3390691"/>
            <a:ext cx="3352795" cy="6160168"/>
          </a:xfrm>
        </p:spPr>
        <p:txBody>
          <a:bodyPr/>
          <a:lstStyle>
            <a:lvl1pPr>
              <a:defRPr sz="2510"/>
            </a:lvl1pPr>
            <a:lvl2pPr>
              <a:defRPr sz="2108"/>
            </a:lvl2pPr>
            <a:lvl3pPr>
              <a:defRPr sz="1907"/>
            </a:lvl3pPr>
            <a:lvl4pPr>
              <a:defRPr sz="1706"/>
            </a:lvl4pPr>
            <a:lvl5pPr>
              <a:defRPr sz="1706"/>
            </a:lvl5pPr>
            <a:lvl6pPr>
              <a:defRPr sz="1706"/>
            </a:lvl6pPr>
            <a:lvl7pPr>
              <a:defRPr sz="1706"/>
            </a:lvl7pPr>
            <a:lvl8pPr>
              <a:defRPr sz="1706"/>
            </a:lvl8pPr>
            <a:lvl9pPr>
              <a:defRPr sz="170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54728" y="2393286"/>
            <a:ext cx="3354112" cy="997407"/>
          </a:xfrm>
        </p:spPr>
        <p:txBody>
          <a:bodyPr anchor="b"/>
          <a:lstStyle>
            <a:lvl1pPr marL="0" indent="0">
              <a:buNone/>
              <a:defRPr sz="2510" b="1"/>
            </a:lvl1pPr>
            <a:lvl2pPr marL="480764" indent="0">
              <a:buNone/>
              <a:defRPr sz="2108" b="1"/>
            </a:lvl2pPr>
            <a:lvl3pPr marL="961527" indent="0">
              <a:buNone/>
              <a:defRPr sz="1907" b="1"/>
            </a:lvl3pPr>
            <a:lvl4pPr marL="1442291" indent="0">
              <a:buNone/>
              <a:defRPr sz="1706" b="1"/>
            </a:lvl4pPr>
            <a:lvl5pPr marL="1923054" indent="0">
              <a:buNone/>
              <a:defRPr sz="1706" b="1"/>
            </a:lvl5pPr>
            <a:lvl6pPr marL="2403818" indent="0">
              <a:buNone/>
              <a:defRPr sz="1706" b="1"/>
            </a:lvl6pPr>
            <a:lvl7pPr marL="2884581" indent="0">
              <a:buNone/>
              <a:defRPr sz="1706" b="1"/>
            </a:lvl7pPr>
            <a:lvl8pPr marL="3365345" indent="0">
              <a:buNone/>
              <a:defRPr sz="1706" b="1"/>
            </a:lvl8pPr>
            <a:lvl9pPr marL="3846109" indent="0">
              <a:buNone/>
              <a:defRPr sz="170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54728" y="3390691"/>
            <a:ext cx="3354112" cy="6160168"/>
          </a:xfrm>
        </p:spPr>
        <p:txBody>
          <a:bodyPr/>
          <a:lstStyle>
            <a:lvl1pPr>
              <a:defRPr sz="2510"/>
            </a:lvl1pPr>
            <a:lvl2pPr>
              <a:defRPr sz="2108"/>
            </a:lvl2pPr>
            <a:lvl3pPr>
              <a:defRPr sz="1907"/>
            </a:lvl3pPr>
            <a:lvl4pPr>
              <a:defRPr sz="1706"/>
            </a:lvl4pPr>
            <a:lvl5pPr>
              <a:defRPr sz="1706"/>
            </a:lvl5pPr>
            <a:lvl6pPr>
              <a:defRPr sz="1706"/>
            </a:lvl6pPr>
            <a:lvl7pPr>
              <a:defRPr sz="1706"/>
            </a:lvl7pPr>
            <a:lvl8pPr>
              <a:defRPr sz="1706"/>
            </a:lvl8pPr>
            <a:lvl9pPr>
              <a:defRPr sz="170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9414" y="425694"/>
            <a:ext cx="2496482" cy="1811669"/>
          </a:xfrm>
        </p:spPr>
        <p:txBody>
          <a:bodyPr anchor="b"/>
          <a:lstStyle>
            <a:lvl1pPr algn="l">
              <a:defRPr sz="2108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66797" y="425695"/>
            <a:ext cx="4242043" cy="9125167"/>
          </a:xfrm>
        </p:spPr>
        <p:txBody>
          <a:bodyPr/>
          <a:lstStyle>
            <a:lvl1pPr>
              <a:defRPr sz="3413"/>
            </a:lvl1pPr>
            <a:lvl2pPr>
              <a:defRPr sz="2911"/>
            </a:lvl2pPr>
            <a:lvl3pPr>
              <a:defRPr sz="2510"/>
            </a:lvl3pPr>
            <a:lvl4pPr>
              <a:defRPr sz="2108"/>
            </a:lvl4pPr>
            <a:lvl5pPr>
              <a:defRPr sz="2108"/>
            </a:lvl5pPr>
            <a:lvl6pPr>
              <a:defRPr sz="2108"/>
            </a:lvl6pPr>
            <a:lvl7pPr>
              <a:defRPr sz="2108"/>
            </a:lvl7pPr>
            <a:lvl8pPr>
              <a:defRPr sz="2108"/>
            </a:lvl8pPr>
            <a:lvl9pPr>
              <a:defRPr sz="210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9414" y="2237362"/>
            <a:ext cx="2496482" cy="7313498"/>
          </a:xfrm>
        </p:spPr>
        <p:txBody>
          <a:bodyPr/>
          <a:lstStyle>
            <a:lvl1pPr marL="0" indent="0">
              <a:buNone/>
              <a:defRPr sz="1506"/>
            </a:lvl1pPr>
            <a:lvl2pPr marL="480764" indent="0">
              <a:buNone/>
              <a:defRPr sz="1205"/>
            </a:lvl2pPr>
            <a:lvl3pPr marL="961527" indent="0">
              <a:buNone/>
              <a:defRPr sz="1004"/>
            </a:lvl3pPr>
            <a:lvl4pPr marL="1442291" indent="0">
              <a:buNone/>
              <a:defRPr sz="903"/>
            </a:lvl4pPr>
            <a:lvl5pPr marL="1923054" indent="0">
              <a:buNone/>
              <a:defRPr sz="903"/>
            </a:lvl5pPr>
            <a:lvl6pPr marL="2403818" indent="0">
              <a:buNone/>
              <a:defRPr sz="903"/>
            </a:lvl6pPr>
            <a:lvl7pPr marL="2884581" indent="0">
              <a:buNone/>
              <a:defRPr sz="903"/>
            </a:lvl7pPr>
            <a:lvl8pPr marL="3365345" indent="0">
              <a:buNone/>
              <a:defRPr sz="903"/>
            </a:lvl8pPr>
            <a:lvl9pPr marL="3846109" indent="0">
              <a:buNone/>
              <a:defRPr sz="90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351" y="7484270"/>
            <a:ext cx="4552950" cy="883561"/>
          </a:xfrm>
        </p:spPr>
        <p:txBody>
          <a:bodyPr anchor="b"/>
          <a:lstStyle>
            <a:lvl1pPr algn="l">
              <a:defRPr sz="2108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87351" y="955334"/>
            <a:ext cx="4552950" cy="6415088"/>
          </a:xfrm>
        </p:spPr>
        <p:txBody>
          <a:bodyPr/>
          <a:lstStyle>
            <a:lvl1pPr marL="0" indent="0">
              <a:buNone/>
              <a:defRPr sz="3413"/>
            </a:lvl1pPr>
            <a:lvl2pPr marL="480764" indent="0">
              <a:buNone/>
              <a:defRPr sz="2911"/>
            </a:lvl2pPr>
            <a:lvl3pPr marL="961527" indent="0">
              <a:buNone/>
              <a:defRPr sz="2510"/>
            </a:lvl3pPr>
            <a:lvl4pPr marL="1442291" indent="0">
              <a:buNone/>
              <a:defRPr sz="2108"/>
            </a:lvl4pPr>
            <a:lvl5pPr marL="1923054" indent="0">
              <a:buNone/>
              <a:defRPr sz="2108"/>
            </a:lvl5pPr>
            <a:lvl6pPr marL="2403818" indent="0">
              <a:buNone/>
              <a:defRPr sz="2108"/>
            </a:lvl6pPr>
            <a:lvl7pPr marL="2884581" indent="0">
              <a:buNone/>
              <a:defRPr sz="2108"/>
            </a:lvl7pPr>
            <a:lvl8pPr marL="3365345" indent="0">
              <a:buNone/>
              <a:defRPr sz="2108"/>
            </a:lvl8pPr>
            <a:lvl9pPr marL="3846109" indent="0">
              <a:buNone/>
              <a:defRPr sz="2108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351" y="8367830"/>
            <a:ext cx="4552950" cy="1254802"/>
          </a:xfrm>
        </p:spPr>
        <p:txBody>
          <a:bodyPr/>
          <a:lstStyle>
            <a:lvl1pPr marL="0" indent="0">
              <a:buNone/>
              <a:defRPr sz="1506"/>
            </a:lvl1pPr>
            <a:lvl2pPr marL="480764" indent="0">
              <a:buNone/>
              <a:defRPr sz="1205"/>
            </a:lvl2pPr>
            <a:lvl3pPr marL="961527" indent="0">
              <a:buNone/>
              <a:defRPr sz="1004"/>
            </a:lvl3pPr>
            <a:lvl4pPr marL="1442291" indent="0">
              <a:buNone/>
              <a:defRPr sz="903"/>
            </a:lvl4pPr>
            <a:lvl5pPr marL="1923054" indent="0">
              <a:buNone/>
              <a:defRPr sz="903"/>
            </a:lvl5pPr>
            <a:lvl6pPr marL="2403818" indent="0">
              <a:buNone/>
              <a:defRPr sz="903"/>
            </a:lvl6pPr>
            <a:lvl7pPr marL="2884581" indent="0">
              <a:buNone/>
              <a:defRPr sz="903"/>
            </a:lvl7pPr>
            <a:lvl8pPr marL="3365345" indent="0">
              <a:buNone/>
              <a:defRPr sz="903"/>
            </a:lvl8pPr>
            <a:lvl9pPr marL="3846109" indent="0">
              <a:buNone/>
              <a:defRPr sz="90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9413" y="428169"/>
            <a:ext cx="6829426" cy="1781969"/>
          </a:xfrm>
          <a:prstGeom prst="rect">
            <a:avLst/>
          </a:prstGeom>
        </p:spPr>
        <p:txBody>
          <a:bodyPr vert="horz" lIns="95789" tIns="47894" rIns="95789" bIns="47894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9413" y="2494758"/>
            <a:ext cx="6829426" cy="7056102"/>
          </a:xfrm>
          <a:prstGeom prst="rect">
            <a:avLst/>
          </a:prstGeom>
        </p:spPr>
        <p:txBody>
          <a:bodyPr vert="horz" lIns="95789" tIns="47894" rIns="95789" bIns="47894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9413" y="9909729"/>
            <a:ext cx="1770591" cy="569240"/>
          </a:xfrm>
          <a:prstGeom prst="rect">
            <a:avLst/>
          </a:prstGeom>
        </p:spPr>
        <p:txBody>
          <a:bodyPr vert="horz" lIns="95789" tIns="47894" rIns="95789" bIns="47894" rtlCol="0" anchor="ctr"/>
          <a:lstStyle>
            <a:lvl1pPr algn="l">
              <a:defRPr sz="12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92654" y="9909729"/>
            <a:ext cx="2402946" cy="569240"/>
          </a:xfrm>
          <a:prstGeom prst="rect">
            <a:avLst/>
          </a:prstGeom>
        </p:spPr>
        <p:txBody>
          <a:bodyPr vert="horz" lIns="95789" tIns="47894" rIns="95789" bIns="47894" rtlCol="0" anchor="ctr"/>
          <a:lstStyle>
            <a:lvl1pPr algn="ctr">
              <a:defRPr sz="12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38246" y="9909729"/>
            <a:ext cx="1770591" cy="569240"/>
          </a:xfrm>
          <a:prstGeom prst="rect">
            <a:avLst/>
          </a:prstGeom>
        </p:spPr>
        <p:txBody>
          <a:bodyPr vert="horz" lIns="95789" tIns="47894" rIns="95789" bIns="47894" rtlCol="0" anchor="ctr"/>
          <a:lstStyle>
            <a:lvl1pPr algn="r">
              <a:defRPr sz="12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61527" rtl="0" eaLnBrk="1" latinLnBrk="0" hangingPunct="1">
        <a:spcBef>
          <a:spcPct val="0"/>
        </a:spcBef>
        <a:buNone/>
        <a:defRPr sz="461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60573" indent="-360573" algn="l" defTabSz="961527" rtl="0" eaLnBrk="1" latinLnBrk="0" hangingPunct="1">
        <a:spcBef>
          <a:spcPct val="20000"/>
        </a:spcBef>
        <a:buFont typeface="Arial" pitchFamily="34" charset="0"/>
        <a:buChar char="•"/>
        <a:defRPr sz="3413" kern="1200">
          <a:solidFill>
            <a:schemeClr val="tx1"/>
          </a:solidFill>
          <a:latin typeface="+mn-lt"/>
          <a:ea typeface="+mn-ea"/>
          <a:cs typeface="+mn-cs"/>
        </a:defRPr>
      </a:lvl1pPr>
      <a:lvl2pPr marL="781240" indent="-300477" algn="l" defTabSz="961527" rtl="0" eaLnBrk="1" latinLnBrk="0" hangingPunct="1">
        <a:spcBef>
          <a:spcPct val="20000"/>
        </a:spcBef>
        <a:buFont typeface="Arial" pitchFamily="34" charset="0"/>
        <a:buChar char="–"/>
        <a:defRPr sz="2911" kern="1200">
          <a:solidFill>
            <a:schemeClr val="tx1"/>
          </a:solidFill>
          <a:latin typeface="+mn-lt"/>
          <a:ea typeface="+mn-ea"/>
          <a:cs typeface="+mn-cs"/>
        </a:defRPr>
      </a:lvl2pPr>
      <a:lvl3pPr marL="1201909" indent="-240382" algn="l" defTabSz="961527" rtl="0" eaLnBrk="1" latinLnBrk="0" hangingPunct="1">
        <a:spcBef>
          <a:spcPct val="20000"/>
        </a:spcBef>
        <a:buFont typeface="Arial" pitchFamily="34" charset="0"/>
        <a:buChar char="•"/>
        <a:defRPr sz="2510" kern="1200">
          <a:solidFill>
            <a:schemeClr val="tx1"/>
          </a:solidFill>
          <a:latin typeface="+mn-lt"/>
          <a:ea typeface="+mn-ea"/>
          <a:cs typeface="+mn-cs"/>
        </a:defRPr>
      </a:lvl3pPr>
      <a:lvl4pPr marL="1682673" indent="-240382" algn="l" defTabSz="961527" rtl="0" eaLnBrk="1" latinLnBrk="0" hangingPunct="1">
        <a:spcBef>
          <a:spcPct val="20000"/>
        </a:spcBef>
        <a:buFont typeface="Arial" pitchFamily="34" charset="0"/>
        <a:buChar char="–"/>
        <a:defRPr sz="2108" kern="1200">
          <a:solidFill>
            <a:schemeClr val="tx1"/>
          </a:solidFill>
          <a:latin typeface="+mn-lt"/>
          <a:ea typeface="+mn-ea"/>
          <a:cs typeface="+mn-cs"/>
        </a:defRPr>
      </a:lvl4pPr>
      <a:lvl5pPr marL="2163436" indent="-240382" algn="l" defTabSz="961527" rtl="0" eaLnBrk="1" latinLnBrk="0" hangingPunct="1">
        <a:spcBef>
          <a:spcPct val="20000"/>
        </a:spcBef>
        <a:buFont typeface="Arial" pitchFamily="34" charset="0"/>
        <a:buChar char="»"/>
        <a:defRPr sz="2108" kern="1200">
          <a:solidFill>
            <a:schemeClr val="tx1"/>
          </a:solidFill>
          <a:latin typeface="+mn-lt"/>
          <a:ea typeface="+mn-ea"/>
          <a:cs typeface="+mn-cs"/>
        </a:defRPr>
      </a:lvl5pPr>
      <a:lvl6pPr marL="2644200" indent="-240382" algn="l" defTabSz="961527" rtl="0" eaLnBrk="1" latinLnBrk="0" hangingPunct="1">
        <a:spcBef>
          <a:spcPct val="20000"/>
        </a:spcBef>
        <a:buFont typeface="Arial" pitchFamily="34" charset="0"/>
        <a:buChar char="•"/>
        <a:defRPr sz="2108" kern="1200">
          <a:solidFill>
            <a:schemeClr val="tx1"/>
          </a:solidFill>
          <a:latin typeface="+mn-lt"/>
          <a:ea typeface="+mn-ea"/>
          <a:cs typeface="+mn-cs"/>
        </a:defRPr>
      </a:lvl6pPr>
      <a:lvl7pPr marL="3124963" indent="-240382" algn="l" defTabSz="961527" rtl="0" eaLnBrk="1" latinLnBrk="0" hangingPunct="1">
        <a:spcBef>
          <a:spcPct val="20000"/>
        </a:spcBef>
        <a:buFont typeface="Arial" pitchFamily="34" charset="0"/>
        <a:buChar char="•"/>
        <a:defRPr sz="2108" kern="1200">
          <a:solidFill>
            <a:schemeClr val="tx1"/>
          </a:solidFill>
          <a:latin typeface="+mn-lt"/>
          <a:ea typeface="+mn-ea"/>
          <a:cs typeface="+mn-cs"/>
        </a:defRPr>
      </a:lvl7pPr>
      <a:lvl8pPr marL="3605727" indent="-240382" algn="l" defTabSz="961527" rtl="0" eaLnBrk="1" latinLnBrk="0" hangingPunct="1">
        <a:spcBef>
          <a:spcPct val="20000"/>
        </a:spcBef>
        <a:buFont typeface="Arial" pitchFamily="34" charset="0"/>
        <a:buChar char="•"/>
        <a:defRPr sz="2108" kern="1200">
          <a:solidFill>
            <a:schemeClr val="tx1"/>
          </a:solidFill>
          <a:latin typeface="+mn-lt"/>
          <a:ea typeface="+mn-ea"/>
          <a:cs typeface="+mn-cs"/>
        </a:defRPr>
      </a:lvl8pPr>
      <a:lvl9pPr marL="4086491" indent="-240382" algn="l" defTabSz="961527" rtl="0" eaLnBrk="1" latinLnBrk="0" hangingPunct="1">
        <a:spcBef>
          <a:spcPct val="20000"/>
        </a:spcBef>
        <a:buFont typeface="Arial" pitchFamily="34" charset="0"/>
        <a:buChar char="•"/>
        <a:defRPr sz="210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1pPr>
      <a:lvl2pPr marL="480764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2pPr>
      <a:lvl3pPr marL="961527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3pPr>
      <a:lvl4pPr marL="1442291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4pPr>
      <a:lvl5pPr marL="1923054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5pPr>
      <a:lvl6pPr marL="2403818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6pPr>
      <a:lvl7pPr marL="2884581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7pPr>
      <a:lvl8pPr marL="3365345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8pPr>
      <a:lvl9pPr marL="3846109" algn="l" defTabSz="961527" rtl="0" eaLnBrk="1" latinLnBrk="0" hangingPunct="1">
        <a:defRPr sz="190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.xml"/><Relationship Id="rId3" Type="http://schemas.openxmlformats.org/officeDocument/2006/relationships/image" Target="../media/image2.png"/><Relationship Id="rId7" Type="http://schemas.openxmlformats.org/officeDocument/2006/relationships/chart" Target="../charts/chart1.xml"/><Relationship Id="rId12" Type="http://schemas.openxmlformats.org/officeDocument/2006/relationships/chart" Target="../charts/chart6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chart" Target="../charts/chart5.xml"/><Relationship Id="rId5" Type="http://schemas.openxmlformats.org/officeDocument/2006/relationships/image" Target="../media/image4.png"/><Relationship Id="rId10" Type="http://schemas.openxmlformats.org/officeDocument/2006/relationships/chart" Target="../charts/chart4.xml"/><Relationship Id="rId4" Type="http://schemas.openxmlformats.org/officeDocument/2006/relationships/image" Target="../media/image3.png"/><Relationship Id="rId9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B540F0C9-FA98-4CCF-81FE-18D0A80B78E1}"/>
              </a:ext>
            </a:extLst>
          </p:cNvPr>
          <p:cNvSpPr txBox="1"/>
          <p:nvPr/>
        </p:nvSpPr>
        <p:spPr>
          <a:xfrm>
            <a:off x="1096277" y="1587484"/>
            <a:ext cx="10174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400" b="0" i="1" dirty="0">
                <a:solidFill>
                  <a:srgbClr val="2E2E2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REBs</a:t>
            </a:r>
            <a:endParaRPr lang="en-IN" sz="1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E4C6041-1AF1-494A-B0F9-AED376436EE1}"/>
              </a:ext>
            </a:extLst>
          </p:cNvPr>
          <p:cNvSpPr txBox="1"/>
          <p:nvPr/>
        </p:nvSpPr>
        <p:spPr>
          <a:xfrm>
            <a:off x="2454883" y="1383101"/>
            <a:ext cx="16795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wall biosynthesis relate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130A55A-D56A-413B-BC07-8073629A4D04}"/>
              </a:ext>
            </a:extLst>
          </p:cNvPr>
          <p:cNvSpPr txBox="1"/>
          <p:nvPr/>
        </p:nvSpPr>
        <p:spPr>
          <a:xfrm>
            <a:off x="4194143" y="1388948"/>
            <a:ext cx="160083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A biosynthesis relate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81589A4-3EC4-402E-8DC0-5ACE58535A13}"/>
              </a:ext>
            </a:extLst>
          </p:cNvPr>
          <p:cNvSpPr txBox="1"/>
          <p:nvPr/>
        </p:nvSpPr>
        <p:spPr>
          <a:xfrm>
            <a:off x="5591157" y="1314661"/>
            <a:ext cx="190658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tochrome P450 related gene</a:t>
            </a:r>
          </a:p>
        </p:txBody>
      </p:sp>
      <p:grpSp>
        <p:nvGrpSpPr>
          <p:cNvPr id="33" name="Group 32">
            <a:extLst>
              <a:ext uri="{FF2B5EF4-FFF2-40B4-BE49-F238E27FC236}">
                <a16:creationId xmlns:a16="http://schemas.microsoft.com/office/drawing/2014/main" id="{71BFA6FF-851B-4F64-816E-21D9A39A1B6F}"/>
              </a:ext>
            </a:extLst>
          </p:cNvPr>
          <p:cNvGrpSpPr/>
          <p:nvPr/>
        </p:nvGrpSpPr>
        <p:grpSpPr>
          <a:xfrm>
            <a:off x="4196719" y="1884178"/>
            <a:ext cx="1520829" cy="1928214"/>
            <a:chOff x="2326001" y="1694724"/>
            <a:chExt cx="1520829" cy="1928214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8CCB0B0E-61A2-4BE2-BC63-B466002CBD0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9681"/>
            <a:stretch/>
          </p:blipFill>
          <p:spPr>
            <a:xfrm>
              <a:off x="2326001" y="1694724"/>
              <a:ext cx="1520829" cy="1268387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F90A65C8-F600-4370-A9E4-C7A7560530E8}"/>
                </a:ext>
              </a:extLst>
            </p:cNvPr>
            <p:cNvSpPr txBox="1"/>
            <p:nvPr/>
          </p:nvSpPr>
          <p:spPr>
            <a:xfrm rot="18510056">
              <a:off x="2141443" y="3060883"/>
              <a:ext cx="77250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I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l-0(Ev)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E4A5A19-F119-46F3-96C2-49F4AA9E2F7A}"/>
                </a:ext>
              </a:extLst>
            </p:cNvPr>
            <p:cNvSpPr txBox="1"/>
            <p:nvPr/>
          </p:nvSpPr>
          <p:spPr>
            <a:xfrm rot="18510056">
              <a:off x="2582522" y="3105880"/>
              <a:ext cx="77250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I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Line4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73C2E22-0E16-4DBB-BF5D-A287D0AAFF6F}"/>
                </a:ext>
              </a:extLst>
            </p:cNvPr>
            <p:cNvSpPr txBox="1"/>
            <p:nvPr/>
          </p:nvSpPr>
          <p:spPr>
            <a:xfrm rot="18510056">
              <a:off x="3022409" y="3070697"/>
              <a:ext cx="77250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I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Line6</a:t>
              </a:r>
            </a:p>
          </p:txBody>
        </p:sp>
      </p:grpSp>
      <p:pic>
        <p:nvPicPr>
          <p:cNvPr id="4" name="Picture 3">
            <a:extLst>
              <a:ext uri="{FF2B5EF4-FFF2-40B4-BE49-F238E27FC236}">
                <a16:creationId xmlns:a16="http://schemas.microsoft.com/office/drawing/2014/main" id="{95DF9615-2F82-4133-8918-E63952EF14D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28803"/>
          <a:stretch/>
        </p:blipFill>
        <p:spPr>
          <a:xfrm>
            <a:off x="752875" y="3922274"/>
            <a:ext cx="1550225" cy="1224551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E152B1A7-EB80-4995-8C3A-4314AA8D5D9F}"/>
              </a:ext>
            </a:extLst>
          </p:cNvPr>
          <p:cNvSpPr txBox="1"/>
          <p:nvPr/>
        </p:nvSpPr>
        <p:spPr>
          <a:xfrm rot="18510056">
            <a:off x="667752" y="5298727"/>
            <a:ext cx="789195" cy="2678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I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-0(Ev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3AC2CF6-E71E-4AC6-9892-A174D6318B71}"/>
              </a:ext>
            </a:extLst>
          </p:cNvPr>
          <p:cNvSpPr txBox="1"/>
          <p:nvPr/>
        </p:nvSpPr>
        <p:spPr>
          <a:xfrm rot="18510056">
            <a:off x="1078963" y="5298727"/>
            <a:ext cx="789195" cy="2678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I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Line4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1F7B5DD-0415-4B68-8AE3-5361EEBB2C12}"/>
              </a:ext>
            </a:extLst>
          </p:cNvPr>
          <p:cNvSpPr txBox="1"/>
          <p:nvPr/>
        </p:nvSpPr>
        <p:spPr>
          <a:xfrm rot="18510056">
            <a:off x="1499930" y="5298728"/>
            <a:ext cx="789195" cy="2678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I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Line6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75367BB-40BD-4F40-ADB7-1F9690464718}"/>
              </a:ext>
            </a:extLst>
          </p:cNvPr>
          <p:cNvSpPr txBox="1"/>
          <p:nvPr/>
        </p:nvSpPr>
        <p:spPr>
          <a:xfrm rot="16200000">
            <a:off x="-775976" y="4591285"/>
            <a:ext cx="2394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fold expression</a:t>
            </a:r>
          </a:p>
        </p:txBody>
      </p:sp>
      <p:grpSp>
        <p:nvGrpSpPr>
          <p:cNvPr id="52" name="Group 51">
            <a:extLst>
              <a:ext uri="{FF2B5EF4-FFF2-40B4-BE49-F238E27FC236}">
                <a16:creationId xmlns:a16="http://schemas.microsoft.com/office/drawing/2014/main" id="{D0906F20-8C23-49EE-BB3D-4A905E9E2152}"/>
              </a:ext>
            </a:extLst>
          </p:cNvPr>
          <p:cNvGrpSpPr/>
          <p:nvPr/>
        </p:nvGrpSpPr>
        <p:grpSpPr>
          <a:xfrm>
            <a:off x="4274688" y="5744732"/>
            <a:ext cx="1596726" cy="1963374"/>
            <a:chOff x="4274688" y="5744732"/>
            <a:chExt cx="1596726" cy="1963374"/>
          </a:xfrm>
        </p:grpSpPr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44A5501B-CA6A-4B84-9718-A7481BC423B8}"/>
                </a:ext>
              </a:extLst>
            </p:cNvPr>
            <p:cNvGrpSpPr/>
            <p:nvPr/>
          </p:nvGrpSpPr>
          <p:grpSpPr>
            <a:xfrm>
              <a:off x="4274688" y="5772556"/>
              <a:ext cx="1596726" cy="1935550"/>
              <a:chOff x="5760085" y="1679488"/>
              <a:chExt cx="1520830" cy="1903609"/>
            </a:xfrm>
          </p:grpSpPr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C5C59405-3640-4E26-8C34-D9E275D7654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b="9773"/>
              <a:stretch/>
            </p:blipFill>
            <p:spPr>
              <a:xfrm>
                <a:off x="5760085" y="1679488"/>
                <a:ext cx="1520830" cy="1264625"/>
              </a:xfrm>
              <a:prstGeom prst="rect">
                <a:avLst/>
              </a:prstGeom>
            </p:spPr>
          </p:pic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905D762C-7F07-480E-AF07-ED3C0E77C819}"/>
                  </a:ext>
                </a:extLst>
              </p:cNvPr>
              <p:cNvSpPr txBox="1"/>
              <p:nvPr/>
            </p:nvSpPr>
            <p:spPr>
              <a:xfrm rot="18510056">
                <a:off x="5716083" y="3066038"/>
                <a:ext cx="77250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IN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l-0(Ev)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4F368A15-186B-4161-A620-F68518BB1D46}"/>
                  </a:ext>
                </a:extLst>
              </p:cNvPr>
              <p:cNvSpPr txBox="1"/>
              <p:nvPr/>
            </p:nvSpPr>
            <p:spPr>
              <a:xfrm rot="18510056">
                <a:off x="6079544" y="3066038"/>
                <a:ext cx="77250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IN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#Line4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2F5748F9-371C-4508-825C-86203EE3D878}"/>
                  </a:ext>
                </a:extLst>
              </p:cNvPr>
              <p:cNvSpPr txBox="1"/>
              <p:nvPr/>
            </p:nvSpPr>
            <p:spPr>
              <a:xfrm rot="18510056">
                <a:off x="6505871" y="3066039"/>
                <a:ext cx="77250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IN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#Line6</a:t>
                </a:r>
              </a:p>
            </p:txBody>
          </p:sp>
        </p:grp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762763F6-E048-43B2-8269-42422D728814}"/>
                </a:ext>
              </a:extLst>
            </p:cNvPr>
            <p:cNvSpPr txBox="1"/>
            <p:nvPr/>
          </p:nvSpPr>
          <p:spPr>
            <a:xfrm>
              <a:off x="4752957" y="5744732"/>
              <a:ext cx="838200" cy="2308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IN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51G04580</a:t>
              </a:r>
            </a:p>
          </p:txBody>
        </p:sp>
      </p:grpSp>
      <p:sp>
        <p:nvSpPr>
          <p:cNvPr id="40" name="TextBox 39">
            <a:extLst>
              <a:ext uri="{FF2B5EF4-FFF2-40B4-BE49-F238E27FC236}">
                <a16:creationId xmlns:a16="http://schemas.microsoft.com/office/drawing/2014/main" id="{D4645A17-4C98-4F8E-89D4-904F20BBA0CD}"/>
              </a:ext>
            </a:extLst>
          </p:cNvPr>
          <p:cNvSpPr txBox="1"/>
          <p:nvPr/>
        </p:nvSpPr>
        <p:spPr>
          <a:xfrm>
            <a:off x="4514412" y="1902497"/>
            <a:ext cx="8382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I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3G24220</a:t>
            </a:r>
          </a:p>
        </p:txBody>
      </p:sp>
      <p:grpSp>
        <p:nvGrpSpPr>
          <p:cNvPr id="55" name="Group 54">
            <a:extLst>
              <a:ext uri="{FF2B5EF4-FFF2-40B4-BE49-F238E27FC236}">
                <a16:creationId xmlns:a16="http://schemas.microsoft.com/office/drawing/2014/main" id="{159D065D-BC45-462A-B3EF-F4D30193AEF9}"/>
              </a:ext>
            </a:extLst>
          </p:cNvPr>
          <p:cNvGrpSpPr/>
          <p:nvPr/>
        </p:nvGrpSpPr>
        <p:grpSpPr>
          <a:xfrm>
            <a:off x="855195" y="5800051"/>
            <a:ext cx="1520830" cy="1921163"/>
            <a:chOff x="701043" y="1975165"/>
            <a:chExt cx="1520830" cy="1921163"/>
          </a:xfrm>
        </p:grpSpPr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E4CA9BC8-4CF0-4107-9491-22E9FD8ABBBF}"/>
                </a:ext>
              </a:extLst>
            </p:cNvPr>
            <p:cNvGrpSpPr/>
            <p:nvPr/>
          </p:nvGrpSpPr>
          <p:grpSpPr>
            <a:xfrm>
              <a:off x="701043" y="1975165"/>
              <a:ext cx="1520830" cy="1921163"/>
              <a:chOff x="570865" y="1694724"/>
              <a:chExt cx="1520830" cy="1921163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E062C0C2-DB04-4BA4-8954-F1DF4DC902E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b="8436"/>
              <a:stretch/>
            </p:blipFill>
            <p:spPr>
              <a:xfrm>
                <a:off x="570865" y="1694724"/>
                <a:ext cx="1520830" cy="1287376"/>
              </a:xfrm>
              <a:prstGeom prst="rect">
                <a:avLst/>
              </a:prstGeom>
            </p:spPr>
          </p:pic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F35A3E14-3E6A-44EF-8F38-CFE19F5B3997}"/>
                  </a:ext>
                </a:extLst>
              </p:cNvPr>
              <p:cNvSpPr txBox="1"/>
              <p:nvPr/>
            </p:nvSpPr>
            <p:spPr>
              <a:xfrm rot="18510056">
                <a:off x="447222" y="3074510"/>
                <a:ext cx="77250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IN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l-0(Ev)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1BF15B26-50A5-483E-9BF5-17CC0B9F7240}"/>
                  </a:ext>
                </a:extLst>
              </p:cNvPr>
              <p:cNvSpPr txBox="1"/>
              <p:nvPr/>
            </p:nvSpPr>
            <p:spPr>
              <a:xfrm rot="18510056">
                <a:off x="879508" y="3098829"/>
                <a:ext cx="77250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IN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#Line4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8E293C9B-A5B1-4C28-89FD-E0BCCDEBDEF2}"/>
                  </a:ext>
                </a:extLst>
              </p:cNvPr>
              <p:cNvSpPr txBox="1"/>
              <p:nvPr/>
            </p:nvSpPr>
            <p:spPr>
              <a:xfrm rot="18510056">
                <a:off x="1311853" y="3079686"/>
                <a:ext cx="77250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IN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#Line6</a:t>
                </a:r>
              </a:p>
            </p:txBody>
          </p:sp>
        </p:grp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C7DC9ACB-953C-484F-9F58-141567ED6FA1}"/>
                </a:ext>
              </a:extLst>
            </p:cNvPr>
            <p:cNvSpPr txBox="1"/>
            <p:nvPr/>
          </p:nvSpPr>
          <p:spPr>
            <a:xfrm>
              <a:off x="1030288" y="2039633"/>
              <a:ext cx="838200" cy="2308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IN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5G17430</a:t>
              </a:r>
            </a:p>
          </p:txBody>
        </p:sp>
      </p:grpSp>
      <p:sp>
        <p:nvSpPr>
          <p:cNvPr id="42" name="TextBox 41">
            <a:extLst>
              <a:ext uri="{FF2B5EF4-FFF2-40B4-BE49-F238E27FC236}">
                <a16:creationId xmlns:a16="http://schemas.microsoft.com/office/drawing/2014/main" id="{CBD5DD47-A564-41F9-ABC7-FB5465B3F3C6}"/>
              </a:ext>
            </a:extLst>
          </p:cNvPr>
          <p:cNvSpPr txBox="1"/>
          <p:nvPr/>
        </p:nvSpPr>
        <p:spPr>
          <a:xfrm>
            <a:off x="1127125" y="4018611"/>
            <a:ext cx="8382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I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1G21910</a:t>
            </a:r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D920F283-03AB-44DA-8EF4-FD118AE1D4D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30673"/>
          <a:stretch/>
        </p:blipFill>
        <p:spPr>
          <a:xfrm>
            <a:off x="4087366" y="3863421"/>
            <a:ext cx="1755472" cy="1332732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D36B77FF-CEB9-4E6A-88EA-0F86CB3AB6B3}"/>
              </a:ext>
            </a:extLst>
          </p:cNvPr>
          <p:cNvSpPr txBox="1"/>
          <p:nvPr/>
        </p:nvSpPr>
        <p:spPr>
          <a:xfrm rot="18510056">
            <a:off x="4121941" y="5261095"/>
            <a:ext cx="78919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I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-0(Ev)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0D493C2-9CF3-4F73-9D82-59501191DC8F}"/>
              </a:ext>
            </a:extLst>
          </p:cNvPr>
          <p:cNvSpPr txBox="1"/>
          <p:nvPr/>
        </p:nvSpPr>
        <p:spPr>
          <a:xfrm rot="18510056">
            <a:off x="4517546" y="5261095"/>
            <a:ext cx="78919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I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Line4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EC6B4CAD-CD17-49D5-98A7-E470E1B6F851}"/>
              </a:ext>
            </a:extLst>
          </p:cNvPr>
          <p:cNvSpPr txBox="1"/>
          <p:nvPr/>
        </p:nvSpPr>
        <p:spPr>
          <a:xfrm rot="18510056">
            <a:off x="4938513" y="5261096"/>
            <a:ext cx="78919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I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Line6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95A29B9-FF2C-4B12-911A-4D4A5337681D}"/>
              </a:ext>
            </a:extLst>
          </p:cNvPr>
          <p:cNvSpPr txBox="1"/>
          <p:nvPr/>
        </p:nvSpPr>
        <p:spPr>
          <a:xfrm>
            <a:off x="4632213" y="3821906"/>
            <a:ext cx="76032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I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1G78390</a:t>
            </a:r>
          </a:p>
        </p:txBody>
      </p:sp>
      <p:graphicFrame>
        <p:nvGraphicFramePr>
          <p:cNvPr id="50" name="Chart 49">
            <a:extLst>
              <a:ext uri="{FF2B5EF4-FFF2-40B4-BE49-F238E27FC236}">
                <a16:creationId xmlns:a16="http://schemas.microsoft.com/office/drawing/2014/main" id="{A8FCB2F1-0A81-4843-A090-D2E960186E7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09729211"/>
              </p:ext>
            </p:extLst>
          </p:nvPr>
        </p:nvGraphicFramePr>
        <p:xfrm>
          <a:off x="5693241" y="1817472"/>
          <a:ext cx="1596727" cy="19282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51" name="TextBox 50">
            <a:extLst>
              <a:ext uri="{FF2B5EF4-FFF2-40B4-BE49-F238E27FC236}">
                <a16:creationId xmlns:a16="http://schemas.microsoft.com/office/drawing/2014/main" id="{CFE27918-9D95-4B6C-9395-01EFD9E41553}"/>
              </a:ext>
            </a:extLst>
          </p:cNvPr>
          <p:cNvSpPr txBox="1"/>
          <p:nvPr/>
        </p:nvSpPr>
        <p:spPr>
          <a:xfrm>
            <a:off x="6097904" y="1929169"/>
            <a:ext cx="8382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I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1G65670</a:t>
            </a:r>
          </a:p>
        </p:txBody>
      </p:sp>
      <p:graphicFrame>
        <p:nvGraphicFramePr>
          <p:cNvPr id="53" name="Chart 52">
            <a:extLst>
              <a:ext uri="{FF2B5EF4-FFF2-40B4-BE49-F238E27FC236}">
                <a16:creationId xmlns:a16="http://schemas.microsoft.com/office/drawing/2014/main" id="{A8FCB2F1-0A81-4843-A090-D2E960186E7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58218103"/>
              </p:ext>
            </p:extLst>
          </p:nvPr>
        </p:nvGraphicFramePr>
        <p:xfrm>
          <a:off x="5681622" y="3709535"/>
          <a:ext cx="1658492" cy="20712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38" name="TextBox 37">
            <a:extLst>
              <a:ext uri="{FF2B5EF4-FFF2-40B4-BE49-F238E27FC236}">
                <a16:creationId xmlns:a16="http://schemas.microsoft.com/office/drawing/2014/main" id="{A0B12AE4-9AF5-4665-AB54-B93F63953CE7}"/>
              </a:ext>
            </a:extLst>
          </p:cNvPr>
          <p:cNvSpPr txBox="1"/>
          <p:nvPr/>
        </p:nvSpPr>
        <p:spPr>
          <a:xfrm>
            <a:off x="6165983" y="3748005"/>
            <a:ext cx="76032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I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5G45340</a:t>
            </a:r>
          </a:p>
        </p:txBody>
      </p:sp>
      <p:graphicFrame>
        <p:nvGraphicFramePr>
          <p:cNvPr id="54" name="Chart 53">
            <a:extLst>
              <a:ext uri="{FF2B5EF4-FFF2-40B4-BE49-F238E27FC236}">
                <a16:creationId xmlns:a16="http://schemas.microsoft.com/office/drawing/2014/main" id="{A8FCB2F1-0A81-4843-A090-D2E960186E7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49887142"/>
              </p:ext>
            </p:extLst>
          </p:nvPr>
        </p:nvGraphicFramePr>
        <p:xfrm>
          <a:off x="2452805" y="5723365"/>
          <a:ext cx="1766411" cy="19726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56" name="TextBox 55">
            <a:extLst>
              <a:ext uri="{FF2B5EF4-FFF2-40B4-BE49-F238E27FC236}">
                <a16:creationId xmlns:a16="http://schemas.microsoft.com/office/drawing/2014/main" id="{9E598D07-BAAB-4369-9FC3-0618C5055DA9}"/>
              </a:ext>
            </a:extLst>
          </p:cNvPr>
          <p:cNvSpPr txBox="1"/>
          <p:nvPr/>
        </p:nvSpPr>
        <p:spPr>
          <a:xfrm>
            <a:off x="3054549" y="5803121"/>
            <a:ext cx="838200" cy="2308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I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4G30440</a:t>
            </a:r>
          </a:p>
        </p:txBody>
      </p:sp>
      <p:graphicFrame>
        <p:nvGraphicFramePr>
          <p:cNvPr id="57" name="Chart 56">
            <a:extLst>
              <a:ext uri="{FF2B5EF4-FFF2-40B4-BE49-F238E27FC236}">
                <a16:creationId xmlns:a16="http://schemas.microsoft.com/office/drawing/2014/main" id="{A8FCB2F1-0A81-4843-A090-D2E960186E7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82437983"/>
              </p:ext>
            </p:extLst>
          </p:nvPr>
        </p:nvGraphicFramePr>
        <p:xfrm>
          <a:off x="2402371" y="1858466"/>
          <a:ext cx="1803122" cy="19897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37" name="TextBox 36">
            <a:extLst>
              <a:ext uri="{FF2B5EF4-FFF2-40B4-BE49-F238E27FC236}">
                <a16:creationId xmlns:a16="http://schemas.microsoft.com/office/drawing/2014/main" id="{285A21E6-5C42-4CB7-AAED-19009BD4172D}"/>
              </a:ext>
            </a:extLst>
          </p:cNvPr>
          <p:cNvSpPr txBox="1"/>
          <p:nvPr/>
        </p:nvSpPr>
        <p:spPr>
          <a:xfrm>
            <a:off x="3147774" y="1943786"/>
            <a:ext cx="76032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I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2G25580</a:t>
            </a:r>
          </a:p>
        </p:txBody>
      </p:sp>
      <p:graphicFrame>
        <p:nvGraphicFramePr>
          <p:cNvPr id="58" name="Chart 57">
            <a:extLst>
              <a:ext uri="{FF2B5EF4-FFF2-40B4-BE49-F238E27FC236}">
                <a16:creationId xmlns:a16="http://schemas.microsoft.com/office/drawing/2014/main" id="{A8FCB2F1-0A81-4843-A090-D2E960186E7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43222906"/>
              </p:ext>
            </p:extLst>
          </p:nvPr>
        </p:nvGraphicFramePr>
        <p:xfrm>
          <a:off x="2477142" y="3821906"/>
          <a:ext cx="1731633" cy="19812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59" name="TextBox 58">
            <a:extLst>
              <a:ext uri="{FF2B5EF4-FFF2-40B4-BE49-F238E27FC236}">
                <a16:creationId xmlns:a16="http://schemas.microsoft.com/office/drawing/2014/main" id="{61D36F2E-C740-405C-98E2-997362F7FEE1}"/>
              </a:ext>
            </a:extLst>
          </p:cNvPr>
          <p:cNvSpPr txBox="1"/>
          <p:nvPr/>
        </p:nvSpPr>
        <p:spPr>
          <a:xfrm>
            <a:off x="3092737" y="3803521"/>
            <a:ext cx="8382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I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5G57530</a:t>
            </a:r>
          </a:p>
        </p:txBody>
      </p:sp>
      <p:graphicFrame>
        <p:nvGraphicFramePr>
          <p:cNvPr id="60" name="Chart 59">
            <a:extLst>
              <a:ext uri="{FF2B5EF4-FFF2-40B4-BE49-F238E27FC236}">
                <a16:creationId xmlns:a16="http://schemas.microsoft.com/office/drawing/2014/main" id="{A8FCB2F1-0A81-4843-A090-D2E960186E7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11601861"/>
              </p:ext>
            </p:extLst>
          </p:nvPr>
        </p:nvGraphicFramePr>
        <p:xfrm>
          <a:off x="669925" y="1851319"/>
          <a:ext cx="1650788" cy="20440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61" name="TextBox 60">
            <a:extLst>
              <a:ext uri="{FF2B5EF4-FFF2-40B4-BE49-F238E27FC236}">
                <a16:creationId xmlns:a16="http://schemas.microsoft.com/office/drawing/2014/main" id="{669282E0-E631-4197-BF73-1462D359EC6F}"/>
              </a:ext>
            </a:extLst>
          </p:cNvPr>
          <p:cNvSpPr txBox="1"/>
          <p:nvPr/>
        </p:nvSpPr>
        <p:spPr>
          <a:xfrm>
            <a:off x="1163890" y="1993106"/>
            <a:ext cx="76032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I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1G12610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D1C11783-5B50-4389-B76C-C8A72D114B10}"/>
              </a:ext>
            </a:extLst>
          </p:cNvPr>
          <p:cNvSpPr txBox="1"/>
          <p:nvPr/>
        </p:nvSpPr>
        <p:spPr>
          <a:xfrm>
            <a:off x="33747" y="164306"/>
            <a:ext cx="379476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Additional file 10: Fig </a:t>
            </a:r>
            <a:r>
              <a:rPr lang="en-IN" sz="1200" b="1" dirty="0">
                <a:latin typeface="Times New Roman" pitchFamily="18" charset="0"/>
                <a:cs typeface="Times New Roman" pitchFamily="18" charset="0"/>
              </a:rPr>
              <a:t>S8: </a:t>
            </a:r>
            <a:endParaRPr lang="en-IN" sz="1200" dirty="0"/>
          </a:p>
        </p:txBody>
      </p:sp>
    </p:spTree>
    <p:extLst>
      <p:ext uri="{BB962C8B-B14F-4D97-AF65-F5344CB8AC3E}">
        <p14:creationId xmlns:p14="http://schemas.microsoft.com/office/powerpoint/2010/main" val="3814694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591</TotalTime>
  <Words>73</Words>
  <Application>Microsoft Office PowerPoint</Application>
  <PresentationFormat>Custom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jay pandey</dc:creator>
  <cp:lastModifiedBy>AK Pandey</cp:lastModifiedBy>
  <cp:revision>442</cp:revision>
  <cp:lastPrinted>2021-05-17T05:57:58Z</cp:lastPrinted>
  <dcterms:created xsi:type="dcterms:W3CDTF">2006-08-16T00:00:00Z</dcterms:created>
  <dcterms:modified xsi:type="dcterms:W3CDTF">2021-11-21T09:48:43Z</dcterms:modified>
</cp:coreProperties>
</file>